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623C8E-04E6-BCB8-1C46-190D45F211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9CDA026-837C-167D-FBB1-DD8B74CF37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F8928EC-BE55-E60B-36A1-723E18B01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90C3E7-0E6B-E8B0-4707-7BBA44DCF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F79E30-BF1E-5029-B738-04CD9C512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7196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486082-E687-6CB6-4360-970B4769C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508440F-8250-10BB-2A3B-BC2DC6DB3B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5F14B01-4702-DF8E-F2F7-DCA8D0107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88BB9EF-8932-BAC9-552B-1FC64BEFB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C8A825F-E396-5638-EA1C-8ECD460E5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065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A435DB6-29BA-40ED-7198-EEE184427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E5539E0-98EC-D786-B009-AC088399D0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986CE4E-DD37-F88C-8642-C58FEDF0A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900C05-F344-33B6-2C34-B0F9AA46F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D4BF71F-4E89-3E4D-FF59-5CED9DC22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7859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A2EEB7-2E91-1DED-9A2B-FC2021025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2B909EF-E266-B5A0-AF2A-5D2E663FF6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D616220-6D58-A589-510C-0A9A42DD9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1B4E2C9-6A34-B40F-CF92-5503C1734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50087AF-814F-8C4E-7AD7-D33C6467B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5361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154D1E3-5BFF-348C-AD76-BDB219A5D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B196853-8BDA-41E5-97AE-DFEDF94F4E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B93C36-61F0-820A-118F-AAF2B5318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24F0017-6F1E-AF43-37BF-A2EE6B3C7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2F6AB5B-B5E6-F5FB-8509-46A65052A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5372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578D44-5CF4-B1A1-8B90-1B41D29784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330A567-C340-1CEE-92D2-EDA0A391B7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F30ABB8-4615-F544-9144-54B5493AF6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E02263F-7D3D-FBBE-8EE9-DDAD582DE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2FA88E0-26D7-82CE-42C2-19BF2A998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A9C8DD3-F8D3-01BA-1667-D5C8E24FC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24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47105F-864B-ACD4-C152-72F242246E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CB579B7-5410-7F08-CDFE-20E28C4E6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FD3E650-0071-7C8A-0636-31604D4C7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9E94EE8-8073-2E86-0C96-4549C581D6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E784748-720D-6BDB-7BEF-009C0FBD1B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913901A-899F-E0DE-2840-244E3EBFF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0CD15AA-BC8E-AC4A-2990-FC56D243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A956CCD-4B20-A3FD-E91A-D701B97CF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9170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63D6DD2-460F-3CB0-0B2F-E1BD038C15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DC05A46-2FEC-876A-E142-5AB73E018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80A96A2-919B-7BFE-6FC3-5CB67B984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C44E961-B572-94A8-471E-8A793F6A9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359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2A147DC-B8EA-8D19-5626-EF4E55090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F5B260B-60B8-8A0D-65B5-718E1EF7B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7021F20-DD86-E357-539D-35449076E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4913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394F1F-EE55-832E-A18A-D8186C89DF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DB19C4E-2C93-7CF0-E4CE-B7813A61B4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9F1F418-81F3-ECB0-6E06-0F9B14C51A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225AFC2-DC74-3DCB-F261-BB757B59C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9131398-62F2-371B-C80B-FF19A9693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5C28117-5FEC-1D04-0FB5-6FE3F7587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3165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1649ABA-B476-D86D-1AB6-E69D8C5E51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4BD688B-8628-7B55-7AE3-4E68310C3A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A30169B-D39B-2E8C-330B-0DA168B01D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255F4D9-81C7-9309-B1F9-15B33E531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7CD0B10-02CC-1436-8E9B-9A27BAD42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93DC30B-4A8A-5D37-4E3A-D0B5825E3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1539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1847025-E805-C028-E2CC-8FD4641DC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1BA90EF-32D6-5837-A01F-715D599A2F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F90DC8F-2810-A987-7FF8-A45254185B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A1339-31E2-4F02-8E01-7BDD2376ABFD}" type="datetimeFigureOut">
              <a:rPr lang="it-IT" smtClean="0"/>
              <a:t>23/09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D6710E9-6AA2-1C41-A1F1-D9FBBA3DE0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1D6F92-A9CD-10E1-CC8F-3885DC73F9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B80EE-E3E6-44E8-B885-EC2B51F0C4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160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8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8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olo 5">
            <a:extLst>
              <a:ext uri="{FF2B5EF4-FFF2-40B4-BE49-F238E27FC236}">
                <a16:creationId xmlns:a16="http://schemas.microsoft.com/office/drawing/2014/main" id="{D779A2CF-BBE3-4604-244E-F627AA0CF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55954" y="339172"/>
            <a:ext cx="2188726" cy="660115"/>
          </a:xfrm>
        </p:spPr>
        <p:txBody>
          <a:bodyPr/>
          <a:lstStyle/>
          <a:p>
            <a:r>
              <a:rPr lang="it-IT" b="1" dirty="0"/>
              <a:t>Videoclip 1</a:t>
            </a:r>
          </a:p>
        </p:txBody>
      </p:sp>
      <p:pic>
        <p:nvPicPr>
          <p:cNvPr id="9" name="VIdeoClip 1">
            <a:hlinkClick r:id="" action="ppaction://media"/>
            <a:extLst>
              <a:ext uri="{FF2B5EF4-FFF2-40B4-BE49-F238E27FC236}">
                <a16:creationId xmlns:a16="http://schemas.microsoft.com/office/drawing/2014/main" id="{5F0918D5-B9AD-F66F-5164-4FA82E59CB6B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450317" y="1335694"/>
            <a:ext cx="6172200" cy="4629150"/>
          </a:xfrm>
        </p:spPr>
      </p:pic>
      <p:sp>
        <p:nvSpPr>
          <p:cNvPr id="8" name="Segnaposto testo 7">
            <a:extLst>
              <a:ext uri="{FF2B5EF4-FFF2-40B4-BE49-F238E27FC236}">
                <a16:creationId xmlns:a16="http://schemas.microsoft.com/office/drawing/2014/main" id="{D460171E-4A3E-B21C-90BC-DFD278EFCA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359596" y="1335694"/>
            <a:ext cx="4900773" cy="4629149"/>
          </a:xfrm>
          <a:solidFill>
            <a:schemeClr val="bg1"/>
          </a:solidFill>
          <a:ln>
            <a:solidFill>
              <a:schemeClr val="tx1"/>
            </a:solidFill>
          </a:ln>
        </p:spPr>
        <p:txBody>
          <a:bodyPr>
            <a:normAutofit fontScale="92500"/>
          </a:bodyPr>
          <a:lstStyle/>
          <a:p>
            <a:r>
              <a:rPr lang="en-GB" sz="2400" dirty="0" err="1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sz="2400" dirty="0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gastrointestinal </a:t>
            </a:r>
            <a:r>
              <a:rPr lang="en-GB" sz="2400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motility visualised </a:t>
            </a:r>
            <a:r>
              <a:rPr lang="en-GB" sz="2400" dirty="0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on day - 10 before parturition (parturition day = day 0) using an 8 - 5 MHz convex transducer connected to a ultrasound (US) unit (Philips </a:t>
            </a:r>
            <a:r>
              <a:rPr lang="en-GB" sz="2400" dirty="0" err="1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Affiniti</a:t>
            </a:r>
            <a:r>
              <a:rPr lang="en-GB" sz="2400" dirty="0">
                <a:solidFill>
                  <a:srgbClr val="3E3D4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50G, Italy). The US was performed in dorsal or lateral recumbency, following hair clipping and application of a contact US gel on the abdominal region. Although the presence of peristalsis in a defined intestinal portion, visible after a prolonged observation of the organ, no</a:t>
            </a:r>
            <a:r>
              <a:rPr lang="en-GB" sz="2400" dirty="0">
                <a:solidFill>
                  <a:srgbClr val="3E3D40"/>
                </a:solidFill>
                <a:cs typeface="Times New Roman" panose="02020603050405020304" pitchFamily="18" charset="0"/>
              </a:rPr>
              <a:t> dilation of the intestine and intraluminal mucous or fluid content were detected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1524366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879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olo 5">
            <a:extLst>
              <a:ext uri="{FF2B5EF4-FFF2-40B4-BE49-F238E27FC236}">
                <a16:creationId xmlns:a16="http://schemas.microsoft.com/office/drawing/2014/main" id="{D779A2CF-BBE3-4604-244E-F627AA0CF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71365" y="349445"/>
            <a:ext cx="2157903" cy="660115"/>
          </a:xfrm>
        </p:spPr>
        <p:txBody>
          <a:bodyPr/>
          <a:lstStyle/>
          <a:p>
            <a:r>
              <a:rPr lang="it-IT" b="1" dirty="0"/>
              <a:t>Videoclip 2</a:t>
            </a:r>
          </a:p>
        </p:txBody>
      </p:sp>
      <p:pic>
        <p:nvPicPr>
          <p:cNvPr id="4" name="VideoClip 2">
            <a:hlinkClick r:id="" action="ppaction://media"/>
            <a:extLst>
              <a:ext uri="{FF2B5EF4-FFF2-40B4-BE49-F238E27FC236}">
                <a16:creationId xmlns:a16="http://schemas.microsoft.com/office/drawing/2014/main" id="{E2D09791-072F-1951-B96A-BC3AAC841441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820185" y="1335693"/>
            <a:ext cx="6172200" cy="4629150"/>
          </a:xfrm>
        </p:spPr>
      </p:pic>
      <p:sp>
        <p:nvSpPr>
          <p:cNvPr id="7" name="Segnaposto testo 6">
            <a:extLst>
              <a:ext uri="{FF2B5EF4-FFF2-40B4-BE49-F238E27FC236}">
                <a16:creationId xmlns:a16="http://schemas.microsoft.com/office/drawing/2014/main" id="{AA96D454-5713-DA77-D278-C07CD7FE97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82886" y="1335693"/>
            <a:ext cx="5167902" cy="4629150"/>
          </a:xfrm>
          <a:solidFill>
            <a:schemeClr val="bg1"/>
          </a:solidFill>
          <a:ln>
            <a:solidFill>
              <a:schemeClr val="tx1"/>
            </a:solidFill>
          </a:ln>
        </p:spPr>
        <p:txBody>
          <a:bodyPr>
            <a:normAutofit fontScale="92500"/>
          </a:bodyPr>
          <a:lstStyle/>
          <a:p>
            <a:r>
              <a:rPr lang="en-GB" sz="2400" dirty="0" err="1">
                <a:solidFill>
                  <a:srgbClr val="3E3D40"/>
                </a:solidFill>
                <a:cs typeface="Times New Roman" panose="02020603050405020304" pitchFamily="18" charset="0"/>
              </a:rPr>
              <a:t>Fetal</a:t>
            </a:r>
            <a:r>
              <a:rPr lang="en-GB" sz="2400" dirty="0">
                <a:solidFill>
                  <a:srgbClr val="3E3D40"/>
                </a:solidFill>
                <a:cs typeface="Times New Roman" panose="02020603050405020304" pitchFamily="18" charset="0"/>
              </a:rPr>
              <a:t> gastrointestinal motility (FGM) visualised on day 0 before parturition (parturition day = day 0) using an 8 - 5 MHz convex transducer connected to a ultrasound (US) unit (Philips </a:t>
            </a:r>
            <a:r>
              <a:rPr lang="en-GB" sz="2400" dirty="0" err="1">
                <a:solidFill>
                  <a:srgbClr val="3E3D40"/>
                </a:solidFill>
                <a:cs typeface="Times New Roman" panose="02020603050405020304" pitchFamily="18" charset="0"/>
              </a:rPr>
              <a:t>Affiniti</a:t>
            </a:r>
            <a:r>
              <a:rPr lang="en-GB" sz="2400" dirty="0">
                <a:solidFill>
                  <a:srgbClr val="3E3D40"/>
                </a:solidFill>
                <a:cs typeface="Times New Roman" panose="02020603050405020304" pitchFamily="18" charset="0"/>
              </a:rPr>
              <a:t> 50G, Italy). The US was performed in dorsal or lateral recumbency, following hair clipping and application of a contact US gel on the abdominal region. FGM was visualized in few seconds of observation and in all the US visualized intestinal portions of the </a:t>
            </a:r>
            <a:r>
              <a:rPr lang="en-GB" sz="2400" dirty="0" err="1">
                <a:solidFill>
                  <a:srgbClr val="3E3D40"/>
                </a:solidFill>
                <a:cs typeface="Times New Roman" panose="02020603050405020304" pitchFamily="18" charset="0"/>
              </a:rPr>
              <a:t>fetus</a:t>
            </a:r>
            <a:r>
              <a:rPr lang="en-GB" sz="2400" dirty="0">
                <a:solidFill>
                  <a:srgbClr val="3E3D40"/>
                </a:solidFill>
                <a:cs typeface="Times New Roman" panose="02020603050405020304" pitchFamily="18" charset="0"/>
              </a:rPr>
              <a:t>. The intestinal wall layers were evident as well as dilation of some intestinal portions and intraluminal mucous and fluid content.</a:t>
            </a:r>
            <a:endParaRPr lang="it-IT" sz="2400" dirty="0"/>
          </a:p>
        </p:txBody>
      </p:sp>
    </p:spTree>
    <p:extLst>
      <p:ext uri="{BB962C8B-B14F-4D97-AF65-F5344CB8AC3E}">
        <p14:creationId xmlns:p14="http://schemas.microsoft.com/office/powerpoint/2010/main" val="42086879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442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211</Words>
  <Application>Microsoft Office PowerPoint</Application>
  <PresentationFormat>Widescreen</PresentationFormat>
  <Paragraphs>4</Paragraphs>
  <Slides>2</Slides>
  <Notes>0</Notes>
  <HiddenSlides>0</HiddenSlides>
  <MMClips>2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Videoclip 1</vt:lpstr>
      <vt:lpstr>Videoclip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ltrasonographic changes in fetal gastrointestinal motility during the last ten days before parturition in dogs</dc:title>
  <dc:creator>Siena Giulia</dc:creator>
  <cp:lastModifiedBy>Siena Giulia</cp:lastModifiedBy>
  <cp:revision>7</cp:revision>
  <dcterms:created xsi:type="dcterms:W3CDTF">2022-08-16T08:05:07Z</dcterms:created>
  <dcterms:modified xsi:type="dcterms:W3CDTF">2022-09-23T08:55:11Z</dcterms:modified>
</cp:coreProperties>
</file>